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62" userDrawn="1">
          <p15:clr>
            <a:srgbClr val="A4A3A4"/>
          </p15:clr>
        </p15:guide>
        <p15:guide id="2" pos="142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B6FF986-82FF-F59F-CE3C-DD1E56EE4F06}" name="martin.koebel@albertaprecisionlabs.ca" initials="ma" userId="S::urn:spo:guest#martin.koebel@albertaprecisionlabs.ca::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akahashi Kazuaki" initials="TK" lastIdx="8" clrIdx="0"/>
  <p:cmAuthor id="2" name="Saner Flurina" initials="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CBE2"/>
    <a:srgbClr val="C5AFD4"/>
    <a:srgbClr val="E2EC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480" autoAdjust="0"/>
    <p:restoredTop sz="96562" autoAdjust="0"/>
  </p:normalViewPr>
  <p:slideViewPr>
    <p:cSldViewPr snapToGrid="0" snapToObjects="1">
      <p:cViewPr>
        <p:scale>
          <a:sx n="169" d="100"/>
          <a:sy n="169" d="100"/>
        </p:scale>
        <p:origin x="904" y="-2536"/>
      </p:cViewPr>
      <p:guideLst>
        <p:guide orient="horz" pos="4662"/>
        <p:guide pos="14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3723A0D-F36C-894A-AF37-B6F6880C4B53}" type="datetimeFigureOut">
              <a:rPr lang="en-US" smtClean="0"/>
              <a:t>5/6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416173-CAE4-5D41-9F10-3306620651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8898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882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348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760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925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474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293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54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0905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878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05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0162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545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02499" y="178858"/>
            <a:ext cx="312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02499" y="2163505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7406" y="2432965"/>
            <a:ext cx="6480000" cy="1511512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FB178B4C-C518-A73A-4AF0-AEA48B43C4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1024" y="338042"/>
            <a:ext cx="2160000" cy="1809536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A2D554F6-FDB1-5DC1-76B8-38754BDFFD0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91246" y="999963"/>
            <a:ext cx="1844720" cy="113220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B8C582F-2706-711E-8168-59AD15089E7A}"/>
              </a:ext>
            </a:extLst>
          </p:cNvPr>
          <p:cNvSpPr txBox="1"/>
          <p:nvPr/>
        </p:nvSpPr>
        <p:spPr>
          <a:xfrm>
            <a:off x="102499" y="3906559"/>
            <a:ext cx="6564907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4.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GSC cell lines with innate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B1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nd/or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RCA1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lterations. (A) Summary of the molecular features of innate HGSC cell models, including alterations in key genes (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P53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DKN2A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RCA1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RCA2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, copy number alterations in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CNE1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and protein expression of RB1 and p16. (B) Viability of high-grade serous ovarian cancer cell lines after treatment with cisplatin (72 hours), paclitaxel (72 hours), or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laparib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120 hours). Data are expressed as mean (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= 3 replicates) ± standard error of the mean (SEM). For some points, error bars are shorter than the height of the symbol and are not visible. </a:t>
            </a:r>
            <a:endParaRPr lang="en-AU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AU" sz="1000" dirty="0"/>
          </a:p>
        </p:txBody>
      </p:sp>
    </p:spTree>
    <p:extLst>
      <p:ext uri="{BB962C8B-B14F-4D97-AF65-F5344CB8AC3E}">
        <p14:creationId xmlns:p14="http://schemas.microsoft.com/office/powerpoint/2010/main" val="82111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74</TotalTime>
  <Words>129</Words>
  <Application>Microsoft Macintosh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sed Dale</dc:creator>
  <cp:lastModifiedBy>Dale Garsed</cp:lastModifiedBy>
  <cp:revision>465</cp:revision>
  <dcterms:created xsi:type="dcterms:W3CDTF">2021-08-30T02:59:35Z</dcterms:created>
  <dcterms:modified xsi:type="dcterms:W3CDTF">2024-05-06T07:04:28Z</dcterms:modified>
</cp:coreProperties>
</file>